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6" r:id="rId2"/>
  </p:sldIdLst>
  <p:sldSz cx="172799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54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5374" autoAdjust="0"/>
  </p:normalViewPr>
  <p:slideViewPr>
    <p:cSldViewPr snapToGrid="0" showGuides="1">
      <p:cViewPr varScale="1">
        <p:scale>
          <a:sx n="93" d="100"/>
          <a:sy n="93" d="100"/>
        </p:scale>
        <p:origin x="440" y="200"/>
      </p:cViewPr>
      <p:guideLst>
        <p:guide orient="horz" pos="2835"/>
        <p:guide pos="54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59992" y="1472842"/>
            <a:ext cx="12959954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59992" y="4726842"/>
            <a:ext cx="12959954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03209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82257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365955" y="479142"/>
            <a:ext cx="3725987" cy="76266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87996" y="479142"/>
            <a:ext cx="10961961" cy="76266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68425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9435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8996" y="2243636"/>
            <a:ext cx="14903947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8996" y="6022609"/>
            <a:ext cx="14903947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45703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87996" y="2395710"/>
            <a:ext cx="7343974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47968" y="2395710"/>
            <a:ext cx="7343974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02433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479143"/>
            <a:ext cx="14903947" cy="1739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90247" y="2206137"/>
            <a:ext cx="7310223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90247" y="3287331"/>
            <a:ext cx="7310223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747969" y="2206137"/>
            <a:ext cx="7346224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747969" y="3287331"/>
            <a:ext cx="7346224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28938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87067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9850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7" y="599969"/>
            <a:ext cx="5573229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346224" y="1295767"/>
            <a:ext cx="8747969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7" y="2699862"/>
            <a:ext cx="5573229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04855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7" y="599969"/>
            <a:ext cx="5573229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346224" y="1295767"/>
            <a:ext cx="8747969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7" y="2699862"/>
            <a:ext cx="5573229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66269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87996" y="479143"/>
            <a:ext cx="14903947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7996" y="2395710"/>
            <a:ext cx="14903947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87996" y="8341239"/>
            <a:ext cx="388798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530A8-00D2-47E4-99B1-0DF56EA1A80E}" type="datetimeFigureOut">
              <a:rPr lang="el-GR" smtClean="0"/>
              <a:t>15/9/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723980" y="8341239"/>
            <a:ext cx="583197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203956" y="8341239"/>
            <a:ext cx="388798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9B012-5B86-4DF5-82A9-26728524E13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20908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3.wdp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9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microsoft.com/office/2007/relationships/hdphoto" Target="../media/hdphoto2.wdp"/><Relationship Id="rId5" Type="http://schemas.openxmlformats.org/officeDocument/2006/relationships/image" Target="../media/image4.emf"/><Relationship Id="rId10" Type="http://schemas.openxmlformats.org/officeDocument/2006/relationships/image" Target="../media/image8.png"/><Relationship Id="rId4" Type="http://schemas.openxmlformats.org/officeDocument/2006/relationships/image" Target="../media/image3.emf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BC8AAEB-2A80-4081-96D9-8CA6B0F9D6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2722"/>
          <a:stretch/>
        </p:blipFill>
        <p:spPr>
          <a:xfrm>
            <a:off x="12440100" y="5349082"/>
            <a:ext cx="4546800" cy="301570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903860C-8E70-46CB-B095-8D6A8EA721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5247"/>
          <a:stretch/>
        </p:blipFill>
        <p:spPr>
          <a:xfrm>
            <a:off x="7036124" y="5379004"/>
            <a:ext cx="4402114" cy="289310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8D5D0D9-2789-4332-8836-BE1BBF248A3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5043"/>
          <a:stretch/>
        </p:blipFill>
        <p:spPr>
          <a:xfrm>
            <a:off x="1265176" y="5365149"/>
            <a:ext cx="4546800" cy="299964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F6F9FB8-8C2E-46A2-8537-11E987FD932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3639"/>
          <a:stretch/>
        </p:blipFill>
        <p:spPr>
          <a:xfrm>
            <a:off x="12429167" y="2222690"/>
            <a:ext cx="4564800" cy="29818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018047F-FA3F-456B-A725-EDDEF3B13E3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5332"/>
          <a:stretch/>
        </p:blipFill>
        <p:spPr>
          <a:xfrm>
            <a:off x="6857411" y="2242298"/>
            <a:ext cx="4564800" cy="292134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5CB17BA-1F07-47F5-974A-9CC501082CF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3571"/>
          <a:stretch/>
        </p:blipFill>
        <p:spPr>
          <a:xfrm>
            <a:off x="1273692" y="2222690"/>
            <a:ext cx="4546800" cy="2934736"/>
          </a:xfrm>
          <a:prstGeom prst="rect">
            <a:avLst/>
          </a:prstGeom>
        </p:spPr>
      </p:pic>
      <p:sp>
        <p:nvSpPr>
          <p:cNvPr id="117" name="TextBox 116">
            <a:extLst>
              <a:ext uri="{FF2B5EF4-FFF2-40B4-BE49-F238E27FC236}">
                <a16:creationId xmlns:a16="http://schemas.microsoft.com/office/drawing/2014/main" id="{F3FA5E00-5F6F-4090-A68C-AB48602C6484}"/>
              </a:ext>
            </a:extLst>
          </p:cNvPr>
          <p:cNvSpPr txBox="1"/>
          <p:nvPr/>
        </p:nvSpPr>
        <p:spPr>
          <a:xfrm rot="16200000">
            <a:off x="-339461" y="6711440"/>
            <a:ext cx="24785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SSC (%, Brix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0F48359-5305-4C2F-95F8-726D892FDA32}"/>
              </a:ext>
            </a:extLst>
          </p:cNvPr>
          <p:cNvSpPr txBox="1"/>
          <p:nvPr/>
        </p:nvSpPr>
        <p:spPr>
          <a:xfrm rot="16200000">
            <a:off x="5263276" y="6698041"/>
            <a:ext cx="26212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TA (%, malate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A2F28C1-8BA5-4C48-AB2D-FDFA5187D3B2}"/>
              </a:ext>
            </a:extLst>
          </p:cNvPr>
          <p:cNvSpPr txBox="1"/>
          <p:nvPr/>
        </p:nvSpPr>
        <p:spPr>
          <a:xfrm>
            <a:off x="4534509" y="6254877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0DB14CD-02E6-4689-A022-EEB000A29BD5}"/>
              </a:ext>
            </a:extLst>
          </p:cNvPr>
          <p:cNvSpPr txBox="1"/>
          <p:nvPr/>
        </p:nvSpPr>
        <p:spPr>
          <a:xfrm rot="16200000">
            <a:off x="10938256" y="6683731"/>
            <a:ext cx="2386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RI (SSC TA</a:t>
            </a:r>
            <a:r>
              <a:rPr lang="en-US" sz="2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5A6D89F-539D-495D-966B-E277F169C733}"/>
              </a:ext>
            </a:extLst>
          </p:cNvPr>
          <p:cNvSpPr txBox="1"/>
          <p:nvPr/>
        </p:nvSpPr>
        <p:spPr>
          <a:xfrm>
            <a:off x="10156573" y="6423178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211EAA27-88D1-49ED-B5C5-5446F5C0A653}"/>
              </a:ext>
            </a:extLst>
          </p:cNvPr>
          <p:cNvSpPr txBox="1"/>
          <p:nvPr/>
        </p:nvSpPr>
        <p:spPr>
          <a:xfrm>
            <a:off x="13879995" y="5953436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31C6B8A-0FA1-4DFE-A05D-6D7F6158B9BE}"/>
              </a:ext>
            </a:extLst>
          </p:cNvPr>
          <p:cNvSpPr txBox="1"/>
          <p:nvPr/>
        </p:nvSpPr>
        <p:spPr>
          <a:xfrm rot="16200000">
            <a:off x="-627550" y="3464294"/>
            <a:ext cx="30796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 err="1"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index (</a:t>
            </a:r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L*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63550EA-CF60-4025-B646-FA633AE5C172}"/>
              </a:ext>
            </a:extLst>
          </p:cNvPr>
          <p:cNvSpPr txBox="1"/>
          <p:nvPr/>
        </p:nvSpPr>
        <p:spPr>
          <a:xfrm>
            <a:off x="2723772" y="3129617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E086A544-4FB8-4631-A0B2-262BDB4C03FA}"/>
              </a:ext>
            </a:extLst>
          </p:cNvPr>
          <p:cNvSpPr txBox="1"/>
          <p:nvPr/>
        </p:nvSpPr>
        <p:spPr>
          <a:xfrm rot="16200000">
            <a:off x="5149290" y="3581515"/>
            <a:ext cx="29001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olor index (</a:t>
            </a:r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C*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38485ED-1116-4CFC-BF30-B8F6F857D763}"/>
              </a:ext>
            </a:extLst>
          </p:cNvPr>
          <p:cNvSpPr txBox="1"/>
          <p:nvPr/>
        </p:nvSpPr>
        <p:spPr>
          <a:xfrm>
            <a:off x="8317897" y="3361001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32171E9-2682-44DD-A0E0-91B629D53125}"/>
              </a:ext>
            </a:extLst>
          </p:cNvPr>
          <p:cNvSpPr txBox="1"/>
          <p:nvPr/>
        </p:nvSpPr>
        <p:spPr>
          <a:xfrm rot="16200000">
            <a:off x="10699640" y="3560127"/>
            <a:ext cx="29001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olor index (</a:t>
            </a:r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H*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CDE86F57-A460-4D84-9FD0-606278830D28}"/>
              </a:ext>
            </a:extLst>
          </p:cNvPr>
          <p:cNvSpPr txBox="1"/>
          <p:nvPr/>
        </p:nvSpPr>
        <p:spPr>
          <a:xfrm>
            <a:off x="13884761" y="3317622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l-GR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07D7557-94C3-4EDF-9583-1EAE54D39D34}"/>
              </a:ext>
            </a:extLst>
          </p:cNvPr>
          <p:cNvSpPr txBox="1"/>
          <p:nvPr/>
        </p:nvSpPr>
        <p:spPr>
          <a:xfrm>
            <a:off x="2100570" y="8321815"/>
            <a:ext cx="1725152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F4B2200-09ED-478B-B121-D66D706D2C17}"/>
              </a:ext>
            </a:extLst>
          </p:cNvPr>
          <p:cNvSpPr txBox="1"/>
          <p:nvPr/>
        </p:nvSpPr>
        <p:spPr>
          <a:xfrm>
            <a:off x="4118387" y="832181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6337FB6D-5346-4D95-9810-536C6A32675B}"/>
              </a:ext>
            </a:extLst>
          </p:cNvPr>
          <p:cNvSpPr txBox="1"/>
          <p:nvPr/>
        </p:nvSpPr>
        <p:spPr>
          <a:xfrm>
            <a:off x="7695129" y="8321815"/>
            <a:ext cx="1725152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6266DCC4-B9A5-446D-B06C-9E074798F1C4}"/>
              </a:ext>
            </a:extLst>
          </p:cNvPr>
          <p:cNvSpPr txBox="1"/>
          <p:nvPr/>
        </p:nvSpPr>
        <p:spPr>
          <a:xfrm>
            <a:off x="9712946" y="832181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E93FF04-BAC7-49A7-9DBB-DEA23C1535F1}"/>
              </a:ext>
            </a:extLst>
          </p:cNvPr>
          <p:cNvSpPr txBox="1"/>
          <p:nvPr/>
        </p:nvSpPr>
        <p:spPr>
          <a:xfrm>
            <a:off x="13267428" y="8321815"/>
            <a:ext cx="1725152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Early Bigi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84E70E38-9194-4672-ABE8-ED281FC54E49}"/>
              </a:ext>
            </a:extLst>
          </p:cNvPr>
          <p:cNvSpPr txBox="1"/>
          <p:nvPr/>
        </p:nvSpPr>
        <p:spPr>
          <a:xfrm>
            <a:off x="15285245" y="832181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Regina</a:t>
            </a:r>
            <a:endParaRPr lang="el-GR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16BD8C3-93DD-4360-993F-F164B41B74CD}"/>
              </a:ext>
            </a:extLst>
          </p:cNvPr>
          <p:cNvSpPr txBox="1"/>
          <p:nvPr/>
        </p:nvSpPr>
        <p:spPr>
          <a:xfrm>
            <a:off x="5077222" y="2486918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54A46AA-DE91-47DF-9549-64E3EC1904DD}"/>
              </a:ext>
            </a:extLst>
          </p:cNvPr>
          <p:cNvSpPr txBox="1"/>
          <p:nvPr/>
        </p:nvSpPr>
        <p:spPr>
          <a:xfrm>
            <a:off x="10695940" y="2461965"/>
            <a:ext cx="3850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AFB5F41-FF9E-41F4-94AE-78177DC13751}"/>
              </a:ext>
            </a:extLst>
          </p:cNvPr>
          <p:cNvSpPr txBox="1"/>
          <p:nvPr/>
        </p:nvSpPr>
        <p:spPr>
          <a:xfrm>
            <a:off x="16277067" y="2458674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4270E338-E7A8-43FE-A5A0-6E68D9698E89}"/>
              </a:ext>
            </a:extLst>
          </p:cNvPr>
          <p:cNvSpPr txBox="1"/>
          <p:nvPr/>
        </p:nvSpPr>
        <p:spPr>
          <a:xfrm>
            <a:off x="5065488" y="5631754"/>
            <a:ext cx="3850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A035FA78-C7CD-4B51-87DF-C1CFD499681F}"/>
              </a:ext>
            </a:extLst>
          </p:cNvPr>
          <p:cNvSpPr txBox="1"/>
          <p:nvPr/>
        </p:nvSpPr>
        <p:spPr>
          <a:xfrm>
            <a:off x="10736014" y="5631754"/>
            <a:ext cx="3048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23DF525-86D4-42CF-8921-C4F5BA785A54}"/>
              </a:ext>
            </a:extLst>
          </p:cNvPr>
          <p:cNvSpPr txBox="1"/>
          <p:nvPr/>
        </p:nvSpPr>
        <p:spPr>
          <a:xfrm>
            <a:off x="16293692" y="5606773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2" name="Picture 141" descr="A picture containing indoor, fruit&#10;&#10;Description automatically generated">
            <a:extLst>
              <a:ext uri="{FF2B5EF4-FFF2-40B4-BE49-F238E27FC236}">
                <a16:creationId xmlns:a16="http://schemas.microsoft.com/office/drawing/2014/main" id="{B5316319-7E6F-41FD-9C7C-5A218068D4C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31766" b="74362" l="12187" r="8635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16" t="26442" r="4375" b="20313"/>
          <a:stretch/>
        </p:blipFill>
        <p:spPr>
          <a:xfrm>
            <a:off x="4678658" y="260362"/>
            <a:ext cx="2350599" cy="1800000"/>
          </a:xfrm>
          <a:prstGeom prst="rect">
            <a:avLst/>
          </a:prstGeom>
        </p:spPr>
      </p:pic>
      <p:pic>
        <p:nvPicPr>
          <p:cNvPr id="143" name="Picture 142" descr="A picture containing tableware&#10;&#10;Description automatically generated">
            <a:extLst>
              <a:ext uri="{FF2B5EF4-FFF2-40B4-BE49-F238E27FC236}">
                <a16:creationId xmlns:a16="http://schemas.microsoft.com/office/drawing/2014/main" id="{B35B2236-A386-439E-95E3-030027DE894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14525" b="58064" l="11835" r="6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5" t="9083" r="32629" b="36494"/>
          <a:stretch/>
        </p:blipFill>
        <p:spPr>
          <a:xfrm rot="5400000">
            <a:off x="7371805" y="-49166"/>
            <a:ext cx="1836765" cy="2160000"/>
          </a:xfrm>
          <a:prstGeom prst="rect">
            <a:avLst/>
          </a:prstGeom>
        </p:spPr>
      </p:pic>
      <p:pic>
        <p:nvPicPr>
          <p:cNvPr id="144" name="Picture 143" descr="A picture containing fruit, cherry&#10;&#10;Description automatically generated">
            <a:extLst>
              <a:ext uri="{FF2B5EF4-FFF2-40B4-BE49-F238E27FC236}">
                <a16:creationId xmlns:a16="http://schemas.microsoft.com/office/drawing/2014/main" id="{EB25AFE6-D3FD-46B2-986B-C684329206F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5740" b="52344" l="6900" r="63881">
                        <a14:foregroundMark x1="62642" y1="44260" x2="65660" y2="37914"/>
                        <a14:foregroundMark x1="65660" y1="37914" x2="63935" y2="24454"/>
                        <a14:foregroundMark x1="63935" y1="24454" x2="62102" y2="21787"/>
                        <a14:foregroundMark x1="43666" y1="19846" x2="40701" y2="24252"/>
                        <a14:foregroundMark x1="43342" y1="21746" x2="45337" y2="23282"/>
                        <a14:foregroundMark x1="24744" y1="52344" x2="33639" y2="52749"/>
                        <a14:foregroundMark x1="33639" y1="52749" x2="42534" y2="51859"/>
                        <a14:foregroundMark x1="42534" y1="51859" x2="51375" y2="51900"/>
                        <a14:foregroundMark x1="51375" y1="51900" x2="24420" y2="52344"/>
                        <a14:foregroundMark x1="24420" y1="52344" x2="33208" y2="53234"/>
                        <a14:foregroundMark x1="33208" y1="53234" x2="42642" y2="52142"/>
                        <a14:foregroundMark x1="42642" y1="52142" x2="38544" y2="52344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0124" b="41851"/>
          <a:stretch/>
        </p:blipFill>
        <p:spPr>
          <a:xfrm>
            <a:off x="9857720" y="-43397"/>
            <a:ext cx="1849386" cy="2052000"/>
          </a:xfrm>
          <a:prstGeom prst="rect">
            <a:avLst/>
          </a:prstGeom>
        </p:spPr>
      </p:pic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28000D7D-2F82-45C4-927D-412FC688CA3B}"/>
              </a:ext>
            </a:extLst>
          </p:cNvPr>
          <p:cNvCxnSpPr>
            <a:cxnSpLocks/>
          </p:cNvCxnSpPr>
          <p:nvPr/>
        </p:nvCxnSpPr>
        <p:spPr>
          <a:xfrm>
            <a:off x="4962616" y="309287"/>
            <a:ext cx="648560" cy="419132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354893D4-B90F-49F0-8BDF-6C46087D5CB8}"/>
              </a:ext>
            </a:extLst>
          </p:cNvPr>
          <p:cNvCxnSpPr>
            <a:cxnSpLocks/>
          </p:cNvCxnSpPr>
          <p:nvPr/>
        </p:nvCxnSpPr>
        <p:spPr>
          <a:xfrm flipH="1">
            <a:off x="6215628" y="202069"/>
            <a:ext cx="342279" cy="361966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BD6CABE4-4EC8-48EF-BF79-152FB66BF54A}"/>
              </a:ext>
            </a:extLst>
          </p:cNvPr>
          <p:cNvCxnSpPr>
            <a:cxnSpLocks/>
          </p:cNvCxnSpPr>
          <p:nvPr/>
        </p:nvCxnSpPr>
        <p:spPr>
          <a:xfrm>
            <a:off x="7467043" y="384865"/>
            <a:ext cx="333331" cy="333383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>
            <a:extLst>
              <a:ext uri="{FF2B5EF4-FFF2-40B4-BE49-F238E27FC236}">
                <a16:creationId xmlns:a16="http://schemas.microsoft.com/office/drawing/2014/main" id="{73D8EE9D-CAE3-4D16-922D-C608639BC1E3}"/>
              </a:ext>
            </a:extLst>
          </p:cNvPr>
          <p:cNvCxnSpPr>
            <a:cxnSpLocks/>
          </p:cNvCxnSpPr>
          <p:nvPr/>
        </p:nvCxnSpPr>
        <p:spPr>
          <a:xfrm flipH="1" flipV="1">
            <a:off x="11391674" y="1775235"/>
            <a:ext cx="572960" cy="296393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Arrow Connector 152">
            <a:extLst>
              <a:ext uri="{FF2B5EF4-FFF2-40B4-BE49-F238E27FC236}">
                <a16:creationId xmlns:a16="http://schemas.microsoft.com/office/drawing/2014/main" id="{05655FEF-641D-4E7C-B12E-FAB114A95DCD}"/>
              </a:ext>
            </a:extLst>
          </p:cNvPr>
          <p:cNvCxnSpPr>
            <a:cxnSpLocks/>
          </p:cNvCxnSpPr>
          <p:nvPr/>
        </p:nvCxnSpPr>
        <p:spPr>
          <a:xfrm flipH="1">
            <a:off x="11406775" y="438426"/>
            <a:ext cx="339086" cy="238234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4006D0C1-0AFA-4D13-8F29-EEED9FF3BA98}"/>
              </a:ext>
            </a:extLst>
          </p:cNvPr>
          <p:cNvCxnSpPr>
            <a:cxnSpLocks/>
          </p:cNvCxnSpPr>
          <p:nvPr/>
        </p:nvCxnSpPr>
        <p:spPr>
          <a:xfrm>
            <a:off x="10344357" y="641186"/>
            <a:ext cx="259882" cy="338142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709D5555-4077-42B0-8F0A-88284A7DC27F}"/>
              </a:ext>
            </a:extLst>
          </p:cNvPr>
          <p:cNvSpPr txBox="1"/>
          <p:nvPr/>
        </p:nvSpPr>
        <p:spPr>
          <a:xfrm>
            <a:off x="1953118" y="-45552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Arrow Connector 145">
            <a:extLst>
              <a:ext uri="{FF2B5EF4-FFF2-40B4-BE49-F238E27FC236}">
                <a16:creationId xmlns:a16="http://schemas.microsoft.com/office/drawing/2014/main" id="{9385CD9B-E1F3-0948-9ECD-DDA08B7BA366}"/>
              </a:ext>
            </a:extLst>
          </p:cNvPr>
          <p:cNvCxnSpPr/>
          <p:nvPr/>
        </p:nvCxnSpPr>
        <p:spPr>
          <a:xfrm>
            <a:off x="12642657" y="982787"/>
            <a:ext cx="504000" cy="0"/>
          </a:xfrm>
          <a:prstGeom prst="straightConnector1">
            <a:avLst/>
          </a:prstGeom>
          <a:ln w="825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97A90E0E-D23E-854D-B66B-AAA5CBF86F11}"/>
              </a:ext>
            </a:extLst>
          </p:cNvPr>
          <p:cNvSpPr txBox="1"/>
          <p:nvPr/>
        </p:nvSpPr>
        <p:spPr>
          <a:xfrm>
            <a:off x="1784697" y="688420"/>
            <a:ext cx="235059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‘Early </a:t>
            </a:r>
            <a:r>
              <a:rPr lang="en-US" sz="2800" b="1" dirty="0" err="1">
                <a:latin typeface="Arial" panose="020B0604020202020204" pitchFamily="34" charset="0"/>
                <a:cs typeface="Arial" panose="020B0604020202020204" pitchFamily="34" charset="0"/>
              </a:rPr>
              <a:t>Bigi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’ cultivar</a:t>
            </a:r>
            <a:endParaRPr lang="el-GR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7002EE8-22CB-0D41-AE01-5E945517610A}"/>
              </a:ext>
            </a:extLst>
          </p:cNvPr>
          <p:cNvSpPr txBox="1"/>
          <p:nvPr/>
        </p:nvSpPr>
        <p:spPr>
          <a:xfrm>
            <a:off x="13127853" y="727640"/>
            <a:ext cx="372089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Cracking symptoms </a:t>
            </a:r>
            <a:endParaRPr lang="el-GR" sz="2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Ευθεία γραμμή σύνδεσης 8">
            <a:extLst>
              <a:ext uri="{FF2B5EF4-FFF2-40B4-BE49-F238E27FC236}">
                <a16:creationId xmlns:a16="http://schemas.microsoft.com/office/drawing/2014/main" id="{219843F8-3712-2643-A02C-C660AAE8049D}"/>
              </a:ext>
            </a:extLst>
          </p:cNvPr>
          <p:cNvCxnSpPr/>
          <p:nvPr/>
        </p:nvCxnSpPr>
        <p:spPr>
          <a:xfrm>
            <a:off x="4316226" y="146957"/>
            <a:ext cx="0" cy="1959177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21110902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</TotalTime>
  <Words>57</Words>
  <Application>Microsoft Macintosh PowerPoint</Application>
  <PresentationFormat>Προσαρμογή</PresentationFormat>
  <Paragraphs>27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</dc:creator>
  <cp:lastModifiedBy>Athanasios Molasiotis</cp:lastModifiedBy>
  <cp:revision>37</cp:revision>
  <dcterms:created xsi:type="dcterms:W3CDTF">2018-05-25T12:22:24Z</dcterms:created>
  <dcterms:modified xsi:type="dcterms:W3CDTF">2021-09-15T10:51:41Z</dcterms:modified>
</cp:coreProperties>
</file>